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94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2395" autoAdjust="0"/>
  </p:normalViewPr>
  <p:slideViewPr>
    <p:cSldViewPr snapToGrid="0" showGuides="1">
      <p:cViewPr>
        <p:scale>
          <a:sx n="75" d="100"/>
          <a:sy n="75" d="100"/>
        </p:scale>
        <p:origin x="1824" y="-972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9210016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45550" y="4229101"/>
            <a:ext cx="57541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 |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ion of elevation level using OTU abundance and functional analysis of the most predictive OTUs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plot of 50 </a:t>
            </a:r>
            <a:r>
              <a:rPr lang="en-US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Sr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els using OTU abundances (from 1,973 significant OTUs) in rhizosphere soil samples to predict their elevation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key’s tests were performed to compare predictions between elevation levels (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8"/>
            <a:ext cx="5760000" cy="3696233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4" name="Image 3" descr="Une image contenant texte, capture d’écran, ligne, Tracé&#10;&#10;Description générée automatiquement">
            <a:extLst>
              <a:ext uri="{FF2B5EF4-FFF2-40B4-BE49-F238E27FC236}">
                <a16:creationId xmlns:a16="http://schemas.microsoft.com/office/drawing/2014/main" id="{87710A25-163F-0E1F-8187-92810C174A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025" y="640034"/>
            <a:ext cx="3060000" cy="2971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774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59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3:59:33Z</dcterms:modified>
</cp:coreProperties>
</file>